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2193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F85E2-4736-4EC2-B565-02DD2A7025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5D50A-C1C7-4968-BFDF-79B3EF5778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39875-2C9E-4BB7-99C8-9656067E1C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33661-8828-4D90-ABFB-804119559C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8B75F-A42D-4459-A78F-71564AB737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6DAC4-E80F-48BD-A0F6-0D16DAFE4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99239-2F56-42BC-B760-ACCD5746D1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1E235-4D62-4FA2-993D-3FF4C72595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649440"/>
            <a:ext cx="59148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221E5-2FFB-473D-A1F1-EF343A0494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417C7-5EA3-450E-9E55-6C25911C99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EFBCD-219D-4B72-8A69-8096B862DF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18D5D-677E-48AE-B15F-8B0808EC36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11299680"/>
            <a:ext cx="23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1C895A1-D448-4BA4-9363-3A001225F682}" type="slidenum">
              <a:rPr b="0" lang="ja-JP" sz="900" spc="-1" strike="noStrike">
                <a:solidFill>
                  <a:srgbClr val="898989"/>
                </a:solidFill>
                <a:latin typeface="Calibri"/>
                <a:ea typeface="游ゴシック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1"/>
          <p:cNvSpPr/>
          <p:nvPr/>
        </p:nvSpPr>
        <p:spPr>
          <a:xfrm>
            <a:off x="1749600" y="60480"/>
            <a:ext cx="1143000" cy="484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tar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正方形/長方形 4"/>
          <p:cNvSpPr/>
          <p:nvPr/>
        </p:nvSpPr>
        <p:spPr>
          <a:xfrm>
            <a:off x="5581800" y="10747440"/>
            <a:ext cx="1143000" cy="484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En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3" name="直線矢印コネクタ 10"/>
          <p:cNvCxnSpPr>
            <a:stCxn id="41" idx="2"/>
            <a:endCxn id="44" idx="0"/>
          </p:cNvCxnSpPr>
          <p:nvPr/>
        </p:nvCxnSpPr>
        <p:spPr>
          <a:xfrm flipH="1">
            <a:off x="2306520" y="544680"/>
            <a:ext cx="14760" cy="235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5" name="フローチャート: データ 43"/>
          <p:cNvSpPr/>
          <p:nvPr/>
        </p:nvSpPr>
        <p:spPr>
          <a:xfrm>
            <a:off x="3308400" y="7539120"/>
            <a:ext cx="2273400" cy="896760"/>
          </a:xfrm>
          <a:prstGeom prst="flowChartInputOutpu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Outpu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matrix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virtual cohort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正方形/長方形 83"/>
          <p:cNvSpPr/>
          <p:nvPr/>
        </p:nvSpPr>
        <p:spPr>
          <a:xfrm>
            <a:off x="892080" y="1271520"/>
            <a:ext cx="2818080" cy="7794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et initial parameters;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g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ex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,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mean / standard deviation of eGFR decline,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st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,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Utility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= 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7" name="直線矢印コネクタ 89"/>
          <p:cNvCxnSpPr>
            <a:endCxn id="48" idx="0"/>
          </p:cNvCxnSpPr>
          <p:nvPr/>
        </p:nvCxnSpPr>
        <p:spPr>
          <a:xfrm>
            <a:off x="4350960" y="8442000"/>
            <a:ext cx="21600" cy="63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9" name="直線矢印コネクタ 92"/>
          <p:cNvCxnSpPr/>
          <p:nvPr/>
        </p:nvCxnSpPr>
        <p:spPr>
          <a:xfrm flipH="1">
            <a:off x="220320" y="9680040"/>
            <a:ext cx="263448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</a:ln>
        </p:spPr>
      </p:cxnSp>
      <p:cxnSp>
        <p:nvCxnSpPr>
          <p:cNvPr id="50" name="直線矢印コネクタ 95"/>
          <p:cNvCxnSpPr/>
          <p:nvPr/>
        </p:nvCxnSpPr>
        <p:spPr>
          <a:xfrm flipV="1">
            <a:off x="220320" y="1653480"/>
            <a:ext cx="1080" cy="8026920"/>
          </a:xfrm>
          <a:prstGeom prst="straightConnector1">
            <a:avLst/>
          </a:prstGeom>
          <a:ln w="6480">
            <a:solidFill>
              <a:srgbClr val="000000"/>
            </a:solidFill>
            <a:miter/>
          </a:ln>
        </p:spPr>
      </p:cxnSp>
      <p:cxnSp>
        <p:nvCxnSpPr>
          <p:cNvPr id="51" name="直線矢印コネクタ 98"/>
          <p:cNvCxnSpPr>
            <a:endCxn id="46" idx="1"/>
          </p:cNvCxnSpPr>
          <p:nvPr/>
        </p:nvCxnSpPr>
        <p:spPr>
          <a:xfrm>
            <a:off x="226800" y="1660320"/>
            <a:ext cx="66564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直線矢印コネクタ 102"/>
          <p:cNvCxnSpPr>
            <a:stCxn id="53" idx="5"/>
            <a:endCxn id="42" idx="1"/>
          </p:cNvCxnSpPr>
          <p:nvPr/>
        </p:nvCxnSpPr>
        <p:spPr>
          <a:xfrm flipV="1">
            <a:off x="4865400" y="10989360"/>
            <a:ext cx="716760" cy="46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" name="フローチャート: 判断 108"/>
          <p:cNvSpPr/>
          <p:nvPr/>
        </p:nvSpPr>
        <p:spPr>
          <a:xfrm>
            <a:off x="2854440" y="9072720"/>
            <a:ext cx="3035160" cy="121752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simulation carried out as the same time as the size of virtual cohor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正方形/長方形 109"/>
          <p:cNvSpPr/>
          <p:nvPr/>
        </p:nvSpPr>
        <p:spPr>
          <a:xfrm>
            <a:off x="414360" y="2638440"/>
            <a:ext cx="5167440" cy="6105600"/>
          </a:xfrm>
          <a:prstGeom prst="rect">
            <a:avLst/>
          </a:prstGeom>
          <a:noFill/>
          <a:ln w="1260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110"/>
          <p:cNvSpPr/>
          <p:nvPr/>
        </p:nvSpPr>
        <p:spPr>
          <a:xfrm>
            <a:off x="3582000" y="2397240"/>
            <a:ext cx="1984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urs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imula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14"/>
          <p:cNvSpPr/>
          <p:nvPr/>
        </p:nvSpPr>
        <p:spPr>
          <a:xfrm>
            <a:off x="1513440" y="968220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フローチャート: データ 115"/>
          <p:cNvSpPr/>
          <p:nvPr/>
        </p:nvSpPr>
        <p:spPr>
          <a:xfrm>
            <a:off x="3335400" y="10618920"/>
            <a:ext cx="1703160" cy="749160"/>
          </a:xfrm>
          <a:prstGeom prst="flowChartInputOutpu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Outpu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virtual cohort time course matrix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7" name="直線矢印コネクタ 117"/>
          <p:cNvCxnSpPr>
            <a:stCxn id="48" idx="2"/>
            <a:endCxn id="53" idx="0"/>
          </p:cNvCxnSpPr>
          <p:nvPr/>
        </p:nvCxnSpPr>
        <p:spPr>
          <a:xfrm flipH="1">
            <a:off x="4357440" y="10290240"/>
            <a:ext cx="15120" cy="329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8" name="テキスト ボックス 121"/>
          <p:cNvSpPr/>
          <p:nvPr/>
        </p:nvSpPr>
        <p:spPr>
          <a:xfrm>
            <a:off x="4448160" y="1035828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正方形/長方形 54"/>
          <p:cNvSpPr/>
          <p:nvPr/>
        </p:nvSpPr>
        <p:spPr>
          <a:xfrm>
            <a:off x="1655640" y="4211640"/>
            <a:ext cx="1143000" cy="4842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enerate Uniform random number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フローチャート: 判断 55"/>
          <p:cNvSpPr/>
          <p:nvPr/>
        </p:nvSpPr>
        <p:spPr>
          <a:xfrm>
            <a:off x="1487520" y="4930920"/>
            <a:ext cx="1479600" cy="65880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&lt; mortality rat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正方形/長方形 57"/>
          <p:cNvSpPr/>
          <p:nvPr/>
        </p:nvSpPr>
        <p:spPr>
          <a:xfrm>
            <a:off x="1049400" y="2716200"/>
            <a:ext cx="2475000" cy="609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Generate lognormal random number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with inputted mean and standard deviation of eGFR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decline spee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正方形/長方形 58"/>
          <p:cNvSpPr/>
          <p:nvPr/>
        </p:nvSpPr>
        <p:spPr>
          <a:xfrm>
            <a:off x="1263600" y="5840280"/>
            <a:ext cx="1965240" cy="987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eGFR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-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ge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+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+ 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st</a:t>
            </a:r>
            <a:r>
              <a:rPr b="0" lang="ja-JP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+Δcost / discount rate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Utility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+ QOL * 1/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フローチャート: 判断 59"/>
          <p:cNvSpPr/>
          <p:nvPr/>
        </p:nvSpPr>
        <p:spPr>
          <a:xfrm>
            <a:off x="1461960" y="7040520"/>
            <a:ext cx="1602000" cy="849240"/>
          </a:xfrm>
          <a:prstGeom prst="flowChartDecision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ime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&gt; simulation length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直線矢印コネクタ 60"/>
          <p:cNvCxnSpPr>
            <a:stCxn id="46" idx="2"/>
            <a:endCxn id="61" idx="0"/>
          </p:cNvCxnSpPr>
          <p:nvPr/>
        </p:nvCxnSpPr>
        <p:spPr>
          <a:xfrm flipH="1">
            <a:off x="2286720" y="2050920"/>
            <a:ext cx="14760" cy="665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5" name="直線矢印コネクタ 61"/>
          <p:cNvCxnSpPr>
            <a:stCxn id="59" idx="2"/>
            <a:endCxn id="60" idx="0"/>
          </p:cNvCxnSpPr>
          <p:nvPr/>
        </p:nvCxnSpPr>
        <p:spPr>
          <a:xfrm>
            <a:off x="2226960" y="4695840"/>
            <a:ext cx="720" cy="235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6" name="直線矢印コネクタ 62"/>
          <p:cNvCxnSpPr>
            <a:stCxn id="60" idx="2"/>
            <a:endCxn id="62" idx="0"/>
          </p:cNvCxnSpPr>
          <p:nvPr/>
        </p:nvCxnSpPr>
        <p:spPr>
          <a:xfrm>
            <a:off x="2227320" y="5589720"/>
            <a:ext cx="19080" cy="2509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7" name="直線矢印コネクタ 63"/>
          <p:cNvCxnSpPr/>
          <p:nvPr/>
        </p:nvCxnSpPr>
        <p:spPr>
          <a:xfrm>
            <a:off x="4573080" y="5261040"/>
            <a:ext cx="1080" cy="22788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直線コネクタ 64"/>
          <p:cNvSpPr/>
          <p:nvPr/>
        </p:nvSpPr>
        <p:spPr>
          <a:xfrm>
            <a:off x="2967120" y="5261040"/>
            <a:ext cx="16063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" name="直線矢印コネクタ 65"/>
          <p:cNvCxnSpPr>
            <a:endCxn id="59" idx="0"/>
          </p:cNvCxnSpPr>
          <p:nvPr/>
        </p:nvCxnSpPr>
        <p:spPr>
          <a:xfrm>
            <a:off x="2226960" y="3979800"/>
            <a:ext cx="360" cy="2322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0" name="直線矢印コネクタ 66"/>
          <p:cNvCxnSpPr>
            <a:endCxn id="59" idx="1"/>
          </p:cNvCxnSpPr>
          <p:nvPr/>
        </p:nvCxnSpPr>
        <p:spPr>
          <a:xfrm flipV="1">
            <a:off x="554040" y="4453560"/>
            <a:ext cx="1101960" cy="5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1" name="直線矢印コネクタ 67"/>
          <p:cNvCxnSpPr>
            <a:endCxn id="45" idx="2"/>
          </p:cNvCxnSpPr>
          <p:nvPr/>
        </p:nvCxnSpPr>
        <p:spPr>
          <a:xfrm flipV="1">
            <a:off x="2262240" y="7987680"/>
            <a:ext cx="1273680" cy="486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2" name="直線コネクタ 68"/>
          <p:cNvSpPr/>
          <p:nvPr/>
        </p:nvSpPr>
        <p:spPr>
          <a:xfrm>
            <a:off x="2262240" y="7889760"/>
            <a:ext cx="0" cy="127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3" name="直線矢印コネクタ 69"/>
          <p:cNvCxnSpPr>
            <a:stCxn id="62" idx="2"/>
            <a:endCxn id="63" idx="0"/>
          </p:cNvCxnSpPr>
          <p:nvPr/>
        </p:nvCxnSpPr>
        <p:spPr>
          <a:xfrm>
            <a:off x="2246040" y="6827760"/>
            <a:ext cx="17280" cy="2131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4" name="直線コネクタ 70"/>
          <p:cNvSpPr/>
          <p:nvPr/>
        </p:nvSpPr>
        <p:spPr>
          <a:xfrm>
            <a:off x="590400" y="7466040"/>
            <a:ext cx="871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直線コネクタ 71"/>
          <p:cNvSpPr/>
          <p:nvPr/>
        </p:nvSpPr>
        <p:spPr>
          <a:xfrm flipV="1">
            <a:off x="554040" y="4454280"/>
            <a:ext cx="0" cy="3011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72"/>
          <p:cNvSpPr/>
          <p:nvPr/>
        </p:nvSpPr>
        <p:spPr>
          <a:xfrm>
            <a:off x="3232080" y="495792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テキスト ボックス 73"/>
          <p:cNvSpPr/>
          <p:nvPr/>
        </p:nvSpPr>
        <p:spPr>
          <a:xfrm>
            <a:off x="2927160" y="7792920"/>
            <a:ext cx="39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Y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74"/>
          <p:cNvSpPr/>
          <p:nvPr/>
        </p:nvSpPr>
        <p:spPr>
          <a:xfrm>
            <a:off x="2201400" y="557388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75"/>
          <p:cNvSpPr/>
          <p:nvPr/>
        </p:nvSpPr>
        <p:spPr>
          <a:xfrm>
            <a:off x="749880" y="7537320"/>
            <a:ext cx="351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No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正方形/長方形 39"/>
          <p:cNvSpPr/>
          <p:nvPr/>
        </p:nvSpPr>
        <p:spPr>
          <a:xfrm>
            <a:off x="1413000" y="3594240"/>
            <a:ext cx="1774800" cy="36648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repar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ersonal time course matri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s void matri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正方形/長方形 40"/>
          <p:cNvSpPr/>
          <p:nvPr/>
        </p:nvSpPr>
        <p:spPr>
          <a:xfrm>
            <a:off x="1398600" y="779400"/>
            <a:ext cx="1816200" cy="3477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Prepar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cohort time course matrix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as void matri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1" name="直線矢印コネクタ 97"/>
          <p:cNvCxnSpPr>
            <a:stCxn id="44" idx="2"/>
            <a:endCxn id="46" idx="0"/>
          </p:cNvCxnSpPr>
          <p:nvPr/>
        </p:nvCxnSpPr>
        <p:spPr>
          <a:xfrm flipH="1">
            <a:off x="2301120" y="1127160"/>
            <a:ext cx="5760" cy="1447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2" name="直線矢印コネクタ 100"/>
          <p:cNvCxnSpPr>
            <a:stCxn id="61" idx="2"/>
            <a:endCxn id="80" idx="0"/>
          </p:cNvCxnSpPr>
          <p:nvPr/>
        </p:nvCxnSpPr>
        <p:spPr>
          <a:xfrm>
            <a:off x="2286720" y="3325680"/>
            <a:ext cx="14040" cy="2689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3" name="テキスト ボックス 4"/>
          <p:cNvSpPr/>
          <p:nvPr/>
        </p:nvSpPr>
        <p:spPr>
          <a:xfrm>
            <a:off x="138960" y="200160"/>
            <a:ext cx="88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Figure</a:t>
            </a:r>
            <a:r>
              <a:rPr b="0" lang="ja-JP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04T02:40:22Z</dcterms:created>
  <dc:creator>SHU HIRAGI</dc:creator>
  <dc:description/>
  <dc:language>en-US</dc:language>
  <cp:lastModifiedBy>Balindan, Danica Joy</cp:lastModifiedBy>
  <cp:lastPrinted>2016-04-04T03:00:45Z</cp:lastPrinted>
  <dcterms:modified xsi:type="dcterms:W3CDTF">2018-10-19T04:33:18Z</dcterms:modified>
  <cp:revision>29</cp:revision>
  <dc:subject/>
  <dc:title>PowerPoint プレゼンテーション</dc:title>
</cp:coreProperties>
</file>